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268" r:id="rId3"/>
    <p:sldId id="293" r:id="rId4"/>
    <p:sldId id="295" r:id="rId5"/>
    <p:sldId id="296" r:id="rId6"/>
    <p:sldId id="297" r:id="rId7"/>
    <p:sldId id="298" r:id="rId8"/>
    <p:sldId id="290" r:id="rId9"/>
    <p:sldId id="284" r:id="rId10"/>
    <p:sldId id="285" r:id="rId11"/>
    <p:sldId id="281" r:id="rId12"/>
  </p:sldIdLst>
  <p:sldSz cx="12192000" cy="6858000"/>
  <p:notesSz cx="6858000" cy="9144000"/>
  <p:defaultTextStyle>
    <a:defPPr>
      <a:defRPr lang="x-non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hnoush Abedi-Ardekani" initials="BA" lastIdx="3" clrIdx="0">
    <p:extLst>
      <p:ext uri="{19B8F6BF-5375-455C-9EA6-DF929625EA0E}">
        <p15:presenceInfo xmlns="" xmlns:p15="http://schemas.microsoft.com/office/powerpoint/2012/main" userId="S::abedib@iarc.fr::87b33485-2212-46a1-ac51-6e365b4c6cc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9260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-118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12-12T00:02:40.299" idx="2">
    <p:pos x="2914" y="733"/>
    <p:text>This arrow was missing in the original file, added here</p:text>
    <p:extLst>
      <p:ext uri="{C676402C-5697-4E1C-873F-D02D1690AC5C}">
        <p15:threadingInfo xmlns="" xmlns:p15="http://schemas.microsoft.com/office/powerpoint/2012/main" timeZoneBias="-60"/>
      </p:ext>
    </p:extLst>
  </p:cm>
  <p:cm authorId="1" dt="2020-12-12T00:03:53.673" idx="3">
    <p:pos x="7677" y="232"/>
    <p:text/>
    <p:extLst>
      <p:ext uri="{C676402C-5697-4E1C-873F-D02D1690AC5C}">
        <p15:threadingInfo xmlns="" xmlns:p15="http://schemas.microsoft.com/office/powerpoint/2012/main" timeZoneBias="-6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CFA2E7-E9BB-C24A-B39C-821226D2D0B7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x-non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870E1-4366-2E4D-A6EF-E9CFD0A0D5F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195506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B72E8B0-296C-A143-87C2-52E67C5094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FA1882A0-312B-8E48-8546-12B313E1BC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B12DEEB-E6A1-B145-84B1-11AC65CF3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2F34C81-3C3D-6C4A-AA7D-CAB326CEF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DC4BF0C-66E0-F84D-B211-AB7FC89D4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074648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26F6C4-06D4-2242-8FE6-87C900C39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4D7FE635-24A4-EB47-9B38-4745E09F3F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B849478-57D2-4D44-8822-73FD8623A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9A93259-A729-6C41-A605-3E93F2ED7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6A02784-3DC4-0F4D-86BA-6A5285779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582477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45E6030B-84B0-9F4B-BB57-98E474AF01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2179B8A6-B3CA-1248-BEF6-238C5B5EFB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490976F-CE83-CA45-88DC-D14242529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274B723-CD60-2D45-8D96-6FC435911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0D6A3D3-F581-334E-818E-4E9EED267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171116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84D79C0-B328-2640-B5C3-885002F9B4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D2B407-8F34-2742-8AB8-A5D2715DD2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E22557B-A326-7244-BAA7-637E3DC85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3A1AF09-9D08-9643-915C-7F5451BF4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5F38BEE-5133-3342-9C91-7D43CBA4D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030669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476E3FF-219C-2246-BEA5-61C77ACDC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CC232B64-A29C-034C-ACC6-785B9C11C4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000C8DF-2A75-6D44-A860-0A17E3BC0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56492DC-7A68-AA4C-94DA-0CC1CDF7F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F95B6C7-497E-B14A-A986-6913B3598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603927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4C3569D-5BC8-6D47-ACE6-59AD4778D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078AAC0-F156-7F4B-86CE-868FC0EC08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0110BA11-6EDB-0E4D-A5AC-4C453D171A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1CA2ECB-D7E8-5E45-B646-573307E3B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993B9CBB-0A34-0849-BB3C-2E3B90655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BC3E86C1-06D3-3C43-A736-516402A77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95047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984EDCA-44E6-FC42-BA81-D25612202B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27299A1-5020-7448-96E5-AF61639C94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2E3FFB72-56C9-AB49-A2A2-FC69419EB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FEFCBF09-ED39-5F4A-A84C-A420B3AF8C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9B99E450-1CE3-3E46-B23D-56215DADCB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5A2B0E07-DEA3-314E-BD93-1BA51E925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ACB1BC68-CD01-0E49-9D61-A718F067C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F22E05ED-C7E5-C54D-A2B3-1CBD6CCB1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722136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C135ED9-ECBB-C240-95E1-1716A0065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81A9A43F-2B23-244A-862A-2DF9A7033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213C91F1-F3B2-9141-87D9-4254BD510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4ECB8963-3074-FF4E-A067-89281F9BE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005605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C454114D-8D68-E04D-9796-3BC76011B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7A0686C3-6CCD-8F4B-A639-5C51F80CC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98CBF983-2114-8148-B72C-F91904060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720070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72534D5-E817-BB49-BB58-85F479004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4649DC3-F456-5748-8737-E50DB30069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3CBFD6A-EF09-D94C-ACEB-6C40573A2F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39A8053-6BB8-364F-BE43-F41EDC69F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1F7949A-B859-2A4B-9E38-ABCDA4791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1FAE59F7-EEF5-F745-9AAE-6D62F7B47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883979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2652C9E-4E29-E342-A469-EB37A539F5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A08451F3-D4E7-9249-873F-7DEA26445A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x-none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CF8D9490-3765-CE4C-A573-F333A64026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B47D0002-C9BE-EA46-9B2C-06B4130A0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95AF5A2E-41F0-E24A-8979-1B4FBF287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3360917-D54E-D74C-B8F7-266195BB3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027414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D9811557-D8DE-1E4D-8ACE-C13300F205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x-none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56A36A74-B975-454D-B902-1FF65EFCEC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6B2CF3E-515A-334B-8871-BF4689B15D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79720-45BB-5948-94B7-20BFA54BE695}" type="datetimeFigureOut">
              <a:rPr lang="x-none" smtClean="0"/>
              <a:t>12/13/2020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34A4FFC-6012-EE48-92A9-FDF7B96DA3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86E14EE-20D2-0941-B874-99FA120EF7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265C5-8133-FD43-BB2D-B87EF86A0499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59043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x-non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CF1F412-3631-CF40-AC68-D0D0FC84656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x-none" dirty="0"/>
              <a:t>Supplementary Data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08487D98-334D-9D4D-BD84-8CA28D5C1EE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x-none"/>
              <a:t>Eight </a:t>
            </a:r>
            <a:r>
              <a:rPr lang="x-none" dirty="0"/>
              <a:t>figures and one Table</a:t>
            </a:r>
          </a:p>
        </p:txBody>
      </p:sp>
    </p:spTree>
    <p:extLst>
      <p:ext uri="{BB962C8B-B14F-4D97-AF65-F5344CB8AC3E}">
        <p14:creationId xmlns:p14="http://schemas.microsoft.com/office/powerpoint/2010/main" val="15378961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9">
            <a:extLst>
              <a:ext uri="{FF2B5EF4-FFF2-40B4-BE49-F238E27FC236}">
                <a16:creationId xmlns="" xmlns:a16="http://schemas.microsoft.com/office/drawing/2014/main" id="{32BC26D8-82FB-445E-AA49-62A77D7C1EE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D676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11">
            <a:extLst>
              <a:ext uri="{FF2B5EF4-FFF2-40B4-BE49-F238E27FC236}">
                <a16:creationId xmlns="" xmlns:a16="http://schemas.microsoft.com/office/drawing/2014/main" id="{CB44330D-EA18-4254-AA95-EB49948539B8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="" xmlns:a16="http://schemas.microsoft.com/office/drawing/2014/main" id="{ACF7254E-B29A-7446-A270-99C4D22774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8851" y="643467"/>
            <a:ext cx="7874298" cy="5571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82470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="" xmlns:a16="http://schemas.microsoft.com/office/drawing/2014/main" id="{CF923B77-1EDB-434D-A646-0B3352F92E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2132869"/>
              </p:ext>
            </p:extLst>
          </p:nvPr>
        </p:nvGraphicFramePr>
        <p:xfrm>
          <a:off x="1263578" y="1444575"/>
          <a:ext cx="9664848" cy="3790668"/>
        </p:xfrm>
        <a:graphic>
          <a:graphicData uri="http://schemas.openxmlformats.org/drawingml/2006/table">
            <a:tbl>
              <a:tblPr firstRow="1" firstCol="1" bandRow="1">
                <a:noFill/>
                <a:tableStyleId>{5C22544A-7EE6-4342-B048-85BDC9FD1C3A}</a:tableStyleId>
              </a:tblPr>
              <a:tblGrid>
                <a:gridCol w="2693878">
                  <a:extLst>
                    <a:ext uri="{9D8B030D-6E8A-4147-A177-3AD203B41FA5}">
                      <a16:colId xmlns="" xmlns:a16="http://schemas.microsoft.com/office/drawing/2014/main" val="1694826088"/>
                    </a:ext>
                  </a:extLst>
                </a:gridCol>
                <a:gridCol w="1599859">
                  <a:extLst>
                    <a:ext uri="{9D8B030D-6E8A-4147-A177-3AD203B41FA5}">
                      <a16:colId xmlns="" xmlns:a16="http://schemas.microsoft.com/office/drawing/2014/main" val="290946649"/>
                    </a:ext>
                  </a:extLst>
                </a:gridCol>
                <a:gridCol w="1464594">
                  <a:extLst>
                    <a:ext uri="{9D8B030D-6E8A-4147-A177-3AD203B41FA5}">
                      <a16:colId xmlns="" xmlns:a16="http://schemas.microsoft.com/office/drawing/2014/main" val="1218300562"/>
                    </a:ext>
                  </a:extLst>
                </a:gridCol>
                <a:gridCol w="1599859">
                  <a:extLst>
                    <a:ext uri="{9D8B030D-6E8A-4147-A177-3AD203B41FA5}">
                      <a16:colId xmlns="" xmlns:a16="http://schemas.microsoft.com/office/drawing/2014/main" val="1685184452"/>
                    </a:ext>
                  </a:extLst>
                </a:gridCol>
                <a:gridCol w="1251826">
                  <a:extLst>
                    <a:ext uri="{9D8B030D-6E8A-4147-A177-3AD203B41FA5}">
                      <a16:colId xmlns="" xmlns:a16="http://schemas.microsoft.com/office/drawing/2014/main" val="2309986194"/>
                    </a:ext>
                  </a:extLst>
                </a:gridCol>
                <a:gridCol w="1054832">
                  <a:extLst>
                    <a:ext uri="{9D8B030D-6E8A-4147-A177-3AD203B41FA5}">
                      <a16:colId xmlns="" xmlns:a16="http://schemas.microsoft.com/office/drawing/2014/main" val="952366168"/>
                    </a:ext>
                  </a:extLst>
                </a:gridCol>
              </a:tblGrid>
              <a:tr h="631778">
                <a:tc>
                  <a:txBody>
                    <a:bodyPr/>
                    <a:lstStyle/>
                    <a:p>
                      <a:pPr algn="r"/>
                      <a:r>
                        <a:rPr lang="en-US" sz="2100" b="1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x-none" sz="21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386803" marT="128934" marB="128934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100" b="1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x-none" sz="21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2100" b="1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Grading proposed by ISN</a:t>
                      </a:r>
                      <a:endParaRPr lang="x-none" sz="21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 b="1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x-none" sz="21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46797593"/>
                  </a:ext>
                </a:extLst>
              </a:tr>
              <a:tr h="631778">
                <a:tc>
                  <a:txBody>
                    <a:bodyPr/>
                    <a:lstStyle/>
                    <a:p>
                      <a:pPr algn="r"/>
                      <a:r>
                        <a:rPr lang="fr-FR" sz="2100" b="1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x-none" sz="21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386803" marT="128934" marB="128934" anchor="b">
                    <a:lnL w="12700" cmpd="sng">
                      <a:noFill/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Mild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Moderate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Severe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Total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8421074"/>
                  </a:ext>
                </a:extLst>
              </a:tr>
              <a:tr h="631778">
                <a:tc rowSpan="3">
                  <a:txBody>
                    <a:bodyPr/>
                    <a:lstStyle/>
                    <a:p>
                      <a:pPr algn="r"/>
                      <a:r>
                        <a:rPr lang="en-US" sz="2100" b="1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Grading used in this study</a:t>
                      </a:r>
                      <a:endParaRPr lang="x-none" sz="21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386803" marT="128934" marB="128934" anchor="ctr">
                    <a:lnL w="12700" cmpd="sng">
                      <a:noFill/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Mild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27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4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0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31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97087430"/>
                  </a:ext>
                </a:extLst>
              </a:tr>
              <a:tr h="631778">
                <a:tc v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Moderate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0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5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1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6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91625221"/>
                  </a:ext>
                </a:extLst>
              </a:tr>
              <a:tr h="631778">
                <a:tc v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Severe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0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3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9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12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EDC"/>
                      </a:solidFill>
                      <a:prstDash val="solid"/>
                    </a:lnL>
                    <a:lnR w="9525" cap="flat" cmpd="sng" algn="ctr">
                      <a:solidFill>
                        <a:srgbClr val="D8DE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243050362"/>
                  </a:ext>
                </a:extLst>
              </a:tr>
              <a:tr h="631778">
                <a:tc>
                  <a:txBody>
                    <a:bodyPr/>
                    <a:lstStyle/>
                    <a:p>
                      <a:pPr algn="r"/>
                      <a:r>
                        <a:rPr lang="fr-FR" sz="21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x-none" sz="21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386803" marT="128934" marB="128934" anchor="b">
                    <a:lnL w="12700" cmpd="sng">
                      <a:noFill/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Total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27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12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10</a:t>
                      </a:r>
                      <a:endParaRPr lang="x-none" sz="210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1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49</a:t>
                      </a:r>
                      <a:endParaRPr lang="x-none" sz="21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57868" marR="96701" marT="128934" marB="128934" anchor="b">
                    <a:lnL w="9525" cap="flat" cmpd="sng" algn="ctr">
                      <a:solidFill>
                        <a:srgbClr val="D8DCDC"/>
                      </a:solidFill>
                      <a:prstDash val="solid"/>
                    </a:lnL>
                    <a:lnR w="9525" cap="flat" cmpd="sng" algn="ctr">
                      <a:solidFill>
                        <a:srgbClr val="D8DCDC"/>
                      </a:solidFill>
                      <a:prstDash val="solid"/>
                    </a:lnR>
                    <a:lnT w="9525" cap="flat" cmpd="sng" algn="ctr">
                      <a:solidFill>
                        <a:srgbClr val="D8DCDC"/>
                      </a:solidFill>
                      <a:prstDash val="solid"/>
                    </a:lnT>
                    <a:lnB w="9525" cap="flat" cmpd="sng" algn="ctr">
                      <a:solidFill>
                        <a:srgbClr val="D8DCDC"/>
                      </a:solidFill>
                      <a:prstDash val="solid"/>
                    </a:lnB>
                    <a:solidFill>
                      <a:srgbClr val="D8DEDC">
                        <a:alpha val="20000"/>
                      </a:srgb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80334384"/>
                  </a:ext>
                </a:extLst>
              </a:tr>
            </a:tbl>
          </a:graphicData>
        </a:graphic>
      </p:graphicFrame>
      <p:sp>
        <p:nvSpPr>
          <p:cNvPr id="3" name="Title 2">
            <a:extLst>
              <a:ext uri="{FF2B5EF4-FFF2-40B4-BE49-F238E27FC236}">
                <a16:creationId xmlns="" xmlns:a16="http://schemas.microsoft.com/office/drawing/2014/main" id="{74EEBDC1-1869-1C41-A5A3-637CB79D7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x-none" sz="2400" dirty="0"/>
              <a:t>Table 1: Comparison of scoring method used in this study with t</a:t>
            </a:r>
            <a:r>
              <a:rPr lang="en-GB" sz="2400" dirty="0"/>
              <a:t>he</a:t>
            </a:r>
            <a:r>
              <a:rPr lang="x-none" sz="2400" dirty="0"/>
              <a:t> one proposed by t</a:t>
            </a:r>
            <a:r>
              <a:rPr lang="en-GB" sz="2400" dirty="0"/>
              <a:t>he</a:t>
            </a:r>
            <a:r>
              <a:rPr lang="x-none" sz="2400" dirty="0"/>
              <a:t> I</a:t>
            </a:r>
            <a:r>
              <a:rPr lang="en-GB" sz="2400" dirty="0"/>
              <a:t>n</a:t>
            </a:r>
            <a:r>
              <a:rPr lang="x-none" sz="2400" dirty="0"/>
              <a:t>ternational Society of Nephrology (ISN)</a:t>
            </a:r>
          </a:p>
        </p:txBody>
      </p:sp>
    </p:spTree>
    <p:extLst>
      <p:ext uri="{BB962C8B-B14F-4D97-AF65-F5344CB8AC3E}">
        <p14:creationId xmlns:p14="http://schemas.microsoft.com/office/powerpoint/2010/main" val="1219800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BACC1A2-6000-AF40-B138-C7875A5950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BFEDA55-88A2-CB4C-B866-E85F794AD1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pPr>
              <a:lnSpc>
                <a:spcPct val="120000"/>
              </a:lnSpc>
            </a:pPr>
            <a:r>
              <a:rPr lang="en-US" sz="36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ological findings in frozen non-neoplastic kidney tissues of patients with kidney cancer from large-scale multicentric studies </a:t>
            </a:r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renal 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  <a:endParaRPr lang="x-none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x-none" sz="36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ournal Name: </a:t>
            </a:r>
            <a:r>
              <a:rPr lang="x-none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rchows Archiv</a:t>
            </a:r>
          </a:p>
          <a:p>
            <a:pPr>
              <a:lnSpc>
                <a:spcPct val="120000"/>
              </a:lnSpc>
            </a:pPr>
            <a:r>
              <a:rPr lang="en-US" sz="36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uthors’ Names: 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hnoush Abedi-Ardekani,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iush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srollahzadeh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ars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evad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amonde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 Banks, Naveen Vasudev, Ivana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lcatov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ibor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vysil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nk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etov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Vladimir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out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na Mates, Viorel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inga</a:t>
            </a:r>
            <a:r>
              <a:rPr lang="en-US" sz="3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melia Petrescu,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s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losavljevic,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odrag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njanovic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imona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njanovic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uris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ksn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ne Y Warren, Mark Lathrop, Yasser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azalhosseini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ristine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reir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stelle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udet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ames McKay</a:t>
            </a:r>
            <a:r>
              <a:rPr lang="en-US" sz="3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aul Brennan</a:t>
            </a:r>
            <a:r>
              <a:rPr lang="en-US" sz="3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hislaine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élo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sz="36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hnoush Abedi-Ardekani; International Agency for Research on Cancer, World Health Organization, Lyon, France; E-mail: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edib@iarc.fr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x-none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x-none" dirty="0"/>
          </a:p>
        </p:txBody>
      </p:sp>
    </p:spTree>
    <p:extLst>
      <p:ext uri="{BB962C8B-B14F-4D97-AF65-F5344CB8AC3E}">
        <p14:creationId xmlns:p14="http://schemas.microsoft.com/office/powerpoint/2010/main" val="22285880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fabric surface&#10;&#10;Description automatically generated">
            <a:extLst>
              <a:ext uri="{FF2B5EF4-FFF2-40B4-BE49-F238E27FC236}">
                <a16:creationId xmlns="" xmlns:a16="http://schemas.microsoft.com/office/drawing/2014/main" id="{E31AC1DF-9368-B24F-84C5-6C7C0AA8C2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1754"/>
            <a:ext cx="12192000" cy="5954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88329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fabric, girl, sitting, table&#10;&#10;Description automatically generated">
            <a:extLst>
              <a:ext uri="{FF2B5EF4-FFF2-40B4-BE49-F238E27FC236}">
                <a16:creationId xmlns="" xmlns:a16="http://schemas.microsoft.com/office/drawing/2014/main" id="{F9DC8493-8F74-1E40-8DE6-B157747EF8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1754"/>
            <a:ext cx="12192000" cy="5954491"/>
          </a:xfrm>
          <a:prstGeom prst="rect">
            <a:avLst/>
          </a:prstGeom>
        </p:spPr>
      </p:pic>
      <p:sp>
        <p:nvSpPr>
          <p:cNvPr id="6" name="Down Arrow 5">
            <a:extLst>
              <a:ext uri="{FF2B5EF4-FFF2-40B4-BE49-F238E27FC236}">
                <a16:creationId xmlns="" xmlns:a16="http://schemas.microsoft.com/office/drawing/2014/main" id="{26D583E4-310A-2245-82E9-F808F90934D1}"/>
              </a:ext>
            </a:extLst>
          </p:cNvPr>
          <p:cNvSpPr/>
          <p:nvPr/>
        </p:nvSpPr>
        <p:spPr>
          <a:xfrm>
            <a:off x="7185773" y="4246178"/>
            <a:ext cx="357352" cy="420713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7" name="Down Arrow 6">
            <a:extLst>
              <a:ext uri="{FF2B5EF4-FFF2-40B4-BE49-F238E27FC236}">
                <a16:creationId xmlns="" xmlns:a16="http://schemas.microsoft.com/office/drawing/2014/main" id="{323CF67C-D8B0-074E-856A-86CC88493338}"/>
              </a:ext>
            </a:extLst>
          </p:cNvPr>
          <p:cNvSpPr/>
          <p:nvPr/>
        </p:nvSpPr>
        <p:spPr>
          <a:xfrm>
            <a:off x="8251671" y="3632975"/>
            <a:ext cx="357352" cy="371465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  <p:sp>
        <p:nvSpPr>
          <p:cNvPr id="8" name="Down Arrow 7">
            <a:extLst>
              <a:ext uri="{FF2B5EF4-FFF2-40B4-BE49-F238E27FC236}">
                <a16:creationId xmlns="" xmlns:a16="http://schemas.microsoft.com/office/drawing/2014/main" id="{0120CCD0-5949-1645-BE08-880CC0709EED}"/>
              </a:ext>
            </a:extLst>
          </p:cNvPr>
          <p:cNvSpPr/>
          <p:nvPr/>
        </p:nvSpPr>
        <p:spPr>
          <a:xfrm>
            <a:off x="1787809" y="578069"/>
            <a:ext cx="357352" cy="38377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9" name="Down Arrow 8">
            <a:extLst>
              <a:ext uri="{FF2B5EF4-FFF2-40B4-BE49-F238E27FC236}">
                <a16:creationId xmlns="" xmlns:a16="http://schemas.microsoft.com/office/drawing/2014/main" id="{5918417B-6E23-4A4F-9C96-1752371D9230}"/>
              </a:ext>
            </a:extLst>
          </p:cNvPr>
          <p:cNvSpPr/>
          <p:nvPr/>
        </p:nvSpPr>
        <p:spPr>
          <a:xfrm>
            <a:off x="5917324" y="2145161"/>
            <a:ext cx="357352" cy="404647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10" name="Chevron 9">
            <a:extLst>
              <a:ext uri="{FF2B5EF4-FFF2-40B4-BE49-F238E27FC236}">
                <a16:creationId xmlns="" xmlns:a16="http://schemas.microsoft.com/office/drawing/2014/main" id="{D1A03D13-3EF9-5E49-8068-E8D4B1640441}"/>
              </a:ext>
            </a:extLst>
          </p:cNvPr>
          <p:cNvSpPr/>
          <p:nvPr/>
        </p:nvSpPr>
        <p:spPr>
          <a:xfrm rot="17128511">
            <a:off x="5954516" y="732010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1" name="Chevron 10">
            <a:extLst>
              <a:ext uri="{FF2B5EF4-FFF2-40B4-BE49-F238E27FC236}">
                <a16:creationId xmlns="" xmlns:a16="http://schemas.microsoft.com/office/drawing/2014/main" id="{8CC1C4E4-425E-1349-B86B-D6A6F823F0EF}"/>
              </a:ext>
            </a:extLst>
          </p:cNvPr>
          <p:cNvSpPr/>
          <p:nvPr/>
        </p:nvSpPr>
        <p:spPr>
          <a:xfrm rot="2377613">
            <a:off x="9033040" y="3762078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30620656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irl, fabric, sitting, table&#10;&#10;Description automatically generated">
            <a:extLst>
              <a:ext uri="{FF2B5EF4-FFF2-40B4-BE49-F238E27FC236}">
                <a16:creationId xmlns="" xmlns:a16="http://schemas.microsoft.com/office/drawing/2014/main" id="{E594BD3A-25D9-864F-AAD6-DD857E00C3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1754"/>
            <a:ext cx="12192000" cy="5954491"/>
          </a:xfrm>
          <a:prstGeom prst="rect">
            <a:avLst/>
          </a:prstGeom>
        </p:spPr>
      </p:pic>
      <p:sp>
        <p:nvSpPr>
          <p:cNvPr id="4" name="Down Arrow 3">
            <a:extLst>
              <a:ext uri="{FF2B5EF4-FFF2-40B4-BE49-F238E27FC236}">
                <a16:creationId xmlns="" xmlns:a16="http://schemas.microsoft.com/office/drawing/2014/main" id="{FE973AA0-5A61-EC4B-AEDA-617CCC115243}"/>
              </a:ext>
            </a:extLst>
          </p:cNvPr>
          <p:cNvSpPr/>
          <p:nvPr/>
        </p:nvSpPr>
        <p:spPr>
          <a:xfrm>
            <a:off x="855541" y="1048632"/>
            <a:ext cx="357352" cy="365458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5" name="Down Arrow 4">
            <a:extLst>
              <a:ext uri="{FF2B5EF4-FFF2-40B4-BE49-F238E27FC236}">
                <a16:creationId xmlns="" xmlns:a16="http://schemas.microsoft.com/office/drawing/2014/main" id="{2F7F7E0F-30D3-EF4A-8BA8-4515FA7E6E66}"/>
              </a:ext>
            </a:extLst>
          </p:cNvPr>
          <p:cNvSpPr/>
          <p:nvPr/>
        </p:nvSpPr>
        <p:spPr>
          <a:xfrm rot="5400000">
            <a:off x="5214708" y="3431338"/>
            <a:ext cx="357352" cy="385892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6" name="Down Arrow 5">
            <a:extLst>
              <a:ext uri="{FF2B5EF4-FFF2-40B4-BE49-F238E27FC236}">
                <a16:creationId xmlns="" xmlns:a16="http://schemas.microsoft.com/office/drawing/2014/main" id="{FE47B4A7-70D9-BB4E-B6D4-B83AC37CE56D}"/>
              </a:ext>
            </a:extLst>
          </p:cNvPr>
          <p:cNvSpPr/>
          <p:nvPr/>
        </p:nvSpPr>
        <p:spPr>
          <a:xfrm rot="1207878">
            <a:off x="4784259" y="5306574"/>
            <a:ext cx="357352" cy="405283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7" name="Down Arrow 6">
            <a:extLst>
              <a:ext uri="{FF2B5EF4-FFF2-40B4-BE49-F238E27FC236}">
                <a16:creationId xmlns="" xmlns:a16="http://schemas.microsoft.com/office/drawing/2014/main" id="{5BBF4A39-A71D-3E40-9406-22BF1175AD94}"/>
              </a:ext>
            </a:extLst>
          </p:cNvPr>
          <p:cNvSpPr/>
          <p:nvPr/>
        </p:nvSpPr>
        <p:spPr>
          <a:xfrm rot="8966941">
            <a:off x="4700736" y="2139564"/>
            <a:ext cx="357352" cy="396178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8" name="Chevron 7">
            <a:extLst>
              <a:ext uri="{FF2B5EF4-FFF2-40B4-BE49-F238E27FC236}">
                <a16:creationId xmlns="" xmlns:a16="http://schemas.microsoft.com/office/drawing/2014/main" id="{B834ABBE-4109-4A4D-BAD0-8D54780B1C50}"/>
              </a:ext>
            </a:extLst>
          </p:cNvPr>
          <p:cNvSpPr/>
          <p:nvPr/>
        </p:nvSpPr>
        <p:spPr>
          <a:xfrm rot="2826942">
            <a:off x="5932061" y="4714268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9" name="Chevron 8">
            <a:extLst>
              <a:ext uri="{FF2B5EF4-FFF2-40B4-BE49-F238E27FC236}">
                <a16:creationId xmlns="" xmlns:a16="http://schemas.microsoft.com/office/drawing/2014/main" id="{DF8FF2FD-B7BC-A54C-9F23-A34B3E7DE17C}"/>
              </a:ext>
            </a:extLst>
          </p:cNvPr>
          <p:cNvSpPr/>
          <p:nvPr/>
        </p:nvSpPr>
        <p:spPr>
          <a:xfrm rot="19426777">
            <a:off x="8588475" y="3814940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0" name="Chevron 9">
            <a:extLst>
              <a:ext uri="{FF2B5EF4-FFF2-40B4-BE49-F238E27FC236}">
                <a16:creationId xmlns="" xmlns:a16="http://schemas.microsoft.com/office/drawing/2014/main" id="{D783543E-BBDD-2549-BEFE-0519E626EB74}"/>
              </a:ext>
            </a:extLst>
          </p:cNvPr>
          <p:cNvSpPr/>
          <p:nvPr/>
        </p:nvSpPr>
        <p:spPr>
          <a:xfrm rot="21225477">
            <a:off x="10705073" y="1478456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="" xmlns:a16="http://schemas.microsoft.com/office/drawing/2014/main" id="{A891B276-38DB-5740-BDAB-BEECEC1A0616}"/>
              </a:ext>
            </a:extLst>
          </p:cNvPr>
          <p:cNvCxnSpPr/>
          <p:nvPr/>
        </p:nvCxnSpPr>
        <p:spPr>
          <a:xfrm flipH="1" flipV="1">
            <a:off x="4029646" y="5581743"/>
            <a:ext cx="127986" cy="653143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="" xmlns:a16="http://schemas.microsoft.com/office/drawing/2014/main" id="{8E7086C8-F33F-C04D-A4FA-99CB822FD699}"/>
              </a:ext>
            </a:extLst>
          </p:cNvPr>
          <p:cNvCxnSpPr/>
          <p:nvPr/>
        </p:nvCxnSpPr>
        <p:spPr>
          <a:xfrm>
            <a:off x="3455802" y="3201978"/>
            <a:ext cx="352697" cy="414423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="" xmlns:a16="http://schemas.microsoft.com/office/drawing/2014/main" id="{084C9623-2104-344D-8ED5-1DCBF3E8CBF5}"/>
              </a:ext>
            </a:extLst>
          </p:cNvPr>
          <p:cNvCxnSpPr>
            <a:cxnSpLocks/>
          </p:cNvCxnSpPr>
          <p:nvPr/>
        </p:nvCxnSpPr>
        <p:spPr>
          <a:xfrm flipV="1">
            <a:off x="4157632" y="5450366"/>
            <a:ext cx="254562" cy="784520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="" xmlns:a16="http://schemas.microsoft.com/office/drawing/2014/main" id="{D407ADFB-8AEC-414C-B088-137D54F84C7F}"/>
              </a:ext>
            </a:extLst>
          </p:cNvPr>
          <p:cNvCxnSpPr>
            <a:cxnSpLocks/>
          </p:cNvCxnSpPr>
          <p:nvPr/>
        </p:nvCxnSpPr>
        <p:spPr>
          <a:xfrm flipV="1">
            <a:off x="6767713" y="4112198"/>
            <a:ext cx="203199" cy="534121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="" xmlns:a16="http://schemas.microsoft.com/office/drawing/2014/main" id="{6731DCFF-4A83-F34F-88E7-79D61BCC4F41}"/>
              </a:ext>
            </a:extLst>
          </p:cNvPr>
          <p:cNvCxnSpPr>
            <a:cxnSpLocks/>
          </p:cNvCxnSpPr>
          <p:nvPr/>
        </p:nvCxnSpPr>
        <p:spPr>
          <a:xfrm flipV="1">
            <a:off x="9342825" y="1641765"/>
            <a:ext cx="203199" cy="534121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91286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some grass&#10;&#10;Description automatically generated">
            <a:extLst>
              <a:ext uri="{FF2B5EF4-FFF2-40B4-BE49-F238E27FC236}">
                <a16:creationId xmlns="" xmlns:a16="http://schemas.microsoft.com/office/drawing/2014/main" id="{3E6EA678-D061-424E-B7D7-A5E9926147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1754"/>
            <a:ext cx="12192000" cy="5954491"/>
          </a:xfrm>
          <a:prstGeom prst="rect">
            <a:avLst/>
          </a:prstGeom>
        </p:spPr>
      </p:pic>
      <p:sp>
        <p:nvSpPr>
          <p:cNvPr id="4" name="7-point Star 3">
            <a:extLst>
              <a:ext uri="{FF2B5EF4-FFF2-40B4-BE49-F238E27FC236}">
                <a16:creationId xmlns="" xmlns:a16="http://schemas.microsoft.com/office/drawing/2014/main" id="{4F56E410-E6AC-4349-9393-FF43E85C1E4C}"/>
              </a:ext>
            </a:extLst>
          </p:cNvPr>
          <p:cNvSpPr/>
          <p:nvPr/>
        </p:nvSpPr>
        <p:spPr>
          <a:xfrm>
            <a:off x="8066090" y="3255916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5" name="7-point Star 4">
            <a:extLst>
              <a:ext uri="{FF2B5EF4-FFF2-40B4-BE49-F238E27FC236}">
                <a16:creationId xmlns="" xmlns:a16="http://schemas.microsoft.com/office/drawing/2014/main" id="{664B3F2C-0311-6842-91A2-865F48CD8BB6}"/>
              </a:ext>
            </a:extLst>
          </p:cNvPr>
          <p:cNvSpPr/>
          <p:nvPr/>
        </p:nvSpPr>
        <p:spPr>
          <a:xfrm>
            <a:off x="2031349" y="2517961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  <p:sp>
        <p:nvSpPr>
          <p:cNvPr id="6" name="7-point Star 5">
            <a:extLst>
              <a:ext uri="{FF2B5EF4-FFF2-40B4-BE49-F238E27FC236}">
                <a16:creationId xmlns="" xmlns:a16="http://schemas.microsoft.com/office/drawing/2014/main" id="{4110A6FA-A30A-EC41-8185-A7CCE9133AFF}"/>
              </a:ext>
            </a:extLst>
          </p:cNvPr>
          <p:cNvSpPr/>
          <p:nvPr/>
        </p:nvSpPr>
        <p:spPr>
          <a:xfrm>
            <a:off x="6503201" y="4819106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7" name="7-point Star 6">
            <a:extLst>
              <a:ext uri="{FF2B5EF4-FFF2-40B4-BE49-F238E27FC236}">
                <a16:creationId xmlns="" xmlns:a16="http://schemas.microsoft.com/office/drawing/2014/main" id="{4E2D7104-342C-7E45-8017-E29DD5715E76}"/>
              </a:ext>
            </a:extLst>
          </p:cNvPr>
          <p:cNvSpPr/>
          <p:nvPr/>
        </p:nvSpPr>
        <p:spPr>
          <a:xfrm>
            <a:off x="11537507" y="2864127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8" name="7-point Star 7">
            <a:extLst>
              <a:ext uri="{FF2B5EF4-FFF2-40B4-BE49-F238E27FC236}">
                <a16:creationId xmlns="" xmlns:a16="http://schemas.microsoft.com/office/drawing/2014/main" id="{0E6DA9A1-582C-074D-BE91-ADC608E5ADE1}"/>
              </a:ext>
            </a:extLst>
          </p:cNvPr>
          <p:cNvSpPr/>
          <p:nvPr/>
        </p:nvSpPr>
        <p:spPr>
          <a:xfrm>
            <a:off x="2031349" y="6015371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="" xmlns:a16="http://schemas.microsoft.com/office/drawing/2014/main" id="{5E942DE9-C663-8E48-A667-076BF8E958E7}"/>
              </a:ext>
            </a:extLst>
          </p:cNvPr>
          <p:cNvCxnSpPr>
            <a:cxnSpLocks/>
          </p:cNvCxnSpPr>
          <p:nvPr/>
        </p:nvCxnSpPr>
        <p:spPr>
          <a:xfrm flipH="1" flipV="1">
            <a:off x="9900744" y="1133991"/>
            <a:ext cx="471164" cy="315985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="" xmlns:a16="http://schemas.microsoft.com/office/drawing/2014/main" id="{59E15216-F5BD-174E-8E3A-1D71BE285A45}"/>
              </a:ext>
            </a:extLst>
          </p:cNvPr>
          <p:cNvCxnSpPr>
            <a:cxnSpLocks/>
          </p:cNvCxnSpPr>
          <p:nvPr/>
        </p:nvCxnSpPr>
        <p:spPr>
          <a:xfrm flipV="1">
            <a:off x="10620103" y="4456069"/>
            <a:ext cx="522062" cy="261800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="" xmlns:a16="http://schemas.microsoft.com/office/drawing/2014/main" id="{72710D8B-3B13-F24A-9A82-2B847B18C64A}"/>
              </a:ext>
            </a:extLst>
          </p:cNvPr>
          <p:cNvCxnSpPr>
            <a:cxnSpLocks/>
          </p:cNvCxnSpPr>
          <p:nvPr/>
        </p:nvCxnSpPr>
        <p:spPr>
          <a:xfrm flipH="1" flipV="1">
            <a:off x="7594926" y="1696484"/>
            <a:ext cx="471164" cy="315985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="" xmlns:a16="http://schemas.microsoft.com/office/drawing/2014/main" id="{D9193FD8-AB7F-0C46-B4FA-559DEDC10FDF}"/>
              </a:ext>
            </a:extLst>
          </p:cNvPr>
          <p:cNvCxnSpPr>
            <a:cxnSpLocks/>
          </p:cNvCxnSpPr>
          <p:nvPr/>
        </p:nvCxnSpPr>
        <p:spPr>
          <a:xfrm flipH="1" flipV="1">
            <a:off x="8392660" y="6015371"/>
            <a:ext cx="471164" cy="315985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321274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fabric, table, rug&#10;&#10;Description automatically generated">
            <a:extLst>
              <a:ext uri="{FF2B5EF4-FFF2-40B4-BE49-F238E27FC236}">
                <a16:creationId xmlns="" xmlns:a16="http://schemas.microsoft.com/office/drawing/2014/main" id="{7EA43BE2-892F-084B-8D18-383DD7CF39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1754"/>
            <a:ext cx="12192000" cy="5954491"/>
          </a:xfrm>
          <a:prstGeom prst="rect">
            <a:avLst/>
          </a:prstGeom>
        </p:spPr>
      </p:pic>
      <p:sp>
        <p:nvSpPr>
          <p:cNvPr id="4" name="7-point Star 3">
            <a:extLst>
              <a:ext uri="{FF2B5EF4-FFF2-40B4-BE49-F238E27FC236}">
                <a16:creationId xmlns="" xmlns:a16="http://schemas.microsoft.com/office/drawing/2014/main" id="{F6D99AE5-532F-3246-A752-353A48D29B1B}"/>
              </a:ext>
            </a:extLst>
          </p:cNvPr>
          <p:cNvSpPr/>
          <p:nvPr/>
        </p:nvSpPr>
        <p:spPr>
          <a:xfrm>
            <a:off x="3770812" y="546460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  <p:sp>
        <p:nvSpPr>
          <p:cNvPr id="5" name="7-point Star 4">
            <a:extLst>
              <a:ext uri="{FF2B5EF4-FFF2-40B4-BE49-F238E27FC236}">
                <a16:creationId xmlns="" xmlns:a16="http://schemas.microsoft.com/office/drawing/2014/main" id="{09C12E92-1B97-F54C-BFC1-C2BBB1E26080}"/>
              </a:ext>
            </a:extLst>
          </p:cNvPr>
          <p:cNvSpPr/>
          <p:nvPr/>
        </p:nvSpPr>
        <p:spPr>
          <a:xfrm>
            <a:off x="4933406" y="3497579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  <p:sp>
        <p:nvSpPr>
          <p:cNvPr id="6" name="7-point Star 5">
            <a:extLst>
              <a:ext uri="{FF2B5EF4-FFF2-40B4-BE49-F238E27FC236}">
                <a16:creationId xmlns="" xmlns:a16="http://schemas.microsoft.com/office/drawing/2014/main" id="{B036A173-7C98-C249-80A7-BDA33EA43205}"/>
              </a:ext>
            </a:extLst>
          </p:cNvPr>
          <p:cNvSpPr/>
          <p:nvPr/>
        </p:nvSpPr>
        <p:spPr>
          <a:xfrm>
            <a:off x="9592492" y="1115785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  <p:sp>
        <p:nvSpPr>
          <p:cNvPr id="7" name="Chevron 6">
            <a:extLst>
              <a:ext uri="{FF2B5EF4-FFF2-40B4-BE49-F238E27FC236}">
                <a16:creationId xmlns="" xmlns:a16="http://schemas.microsoft.com/office/drawing/2014/main" id="{CB24C630-C424-9144-8201-04DA4C2A59EA}"/>
              </a:ext>
            </a:extLst>
          </p:cNvPr>
          <p:cNvSpPr/>
          <p:nvPr/>
        </p:nvSpPr>
        <p:spPr>
          <a:xfrm rot="15179949">
            <a:off x="10450700" y="1497927"/>
            <a:ext cx="316920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8" name="Chevron 7">
            <a:extLst>
              <a:ext uri="{FF2B5EF4-FFF2-40B4-BE49-F238E27FC236}">
                <a16:creationId xmlns="" xmlns:a16="http://schemas.microsoft.com/office/drawing/2014/main" id="{732023CD-4BDF-E146-8242-8742F0B408D9}"/>
              </a:ext>
            </a:extLst>
          </p:cNvPr>
          <p:cNvSpPr/>
          <p:nvPr/>
        </p:nvSpPr>
        <p:spPr>
          <a:xfrm rot="11779836">
            <a:off x="9897409" y="4786430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9" name="Chevron 8">
            <a:extLst>
              <a:ext uri="{FF2B5EF4-FFF2-40B4-BE49-F238E27FC236}">
                <a16:creationId xmlns="" xmlns:a16="http://schemas.microsoft.com/office/drawing/2014/main" id="{8E640BB5-C725-D94C-9816-6DB2712F94F1}"/>
              </a:ext>
            </a:extLst>
          </p:cNvPr>
          <p:cNvSpPr/>
          <p:nvPr/>
        </p:nvSpPr>
        <p:spPr>
          <a:xfrm rot="15430835">
            <a:off x="7309069" y="5394600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0" name="Chevron 9">
            <a:extLst>
              <a:ext uri="{FF2B5EF4-FFF2-40B4-BE49-F238E27FC236}">
                <a16:creationId xmlns="" xmlns:a16="http://schemas.microsoft.com/office/drawing/2014/main" id="{F4C1404F-C93C-B14F-9CC7-0A07EC21BFFB}"/>
              </a:ext>
            </a:extLst>
          </p:cNvPr>
          <p:cNvSpPr/>
          <p:nvPr/>
        </p:nvSpPr>
        <p:spPr>
          <a:xfrm rot="3107650">
            <a:off x="2026910" y="4390602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1" name="Chevron 10">
            <a:extLst>
              <a:ext uri="{FF2B5EF4-FFF2-40B4-BE49-F238E27FC236}">
                <a16:creationId xmlns="" xmlns:a16="http://schemas.microsoft.com/office/drawing/2014/main" id="{59EA8863-3316-C24A-BAAF-4DBFE320D7C1}"/>
              </a:ext>
            </a:extLst>
          </p:cNvPr>
          <p:cNvSpPr/>
          <p:nvPr/>
        </p:nvSpPr>
        <p:spPr>
          <a:xfrm rot="1408089">
            <a:off x="462441" y="2934116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2" name="Chevron 11">
            <a:extLst>
              <a:ext uri="{FF2B5EF4-FFF2-40B4-BE49-F238E27FC236}">
                <a16:creationId xmlns="" xmlns:a16="http://schemas.microsoft.com/office/drawing/2014/main" id="{66657EBD-5657-084C-8FA5-B36304A3C6F5}"/>
              </a:ext>
            </a:extLst>
          </p:cNvPr>
          <p:cNvSpPr/>
          <p:nvPr/>
        </p:nvSpPr>
        <p:spPr>
          <a:xfrm rot="17935793">
            <a:off x="2151679" y="1054388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3" name="Chevron 12">
            <a:extLst>
              <a:ext uri="{FF2B5EF4-FFF2-40B4-BE49-F238E27FC236}">
                <a16:creationId xmlns="" xmlns:a16="http://schemas.microsoft.com/office/drawing/2014/main" id="{F729E186-6516-8F49-B43C-EDBE03EE7C4B}"/>
              </a:ext>
            </a:extLst>
          </p:cNvPr>
          <p:cNvSpPr/>
          <p:nvPr/>
        </p:nvSpPr>
        <p:spPr>
          <a:xfrm rot="7697671">
            <a:off x="506653" y="5349145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sp>
        <p:nvSpPr>
          <p:cNvPr id="14" name="Chevron 13">
            <a:extLst>
              <a:ext uri="{FF2B5EF4-FFF2-40B4-BE49-F238E27FC236}">
                <a16:creationId xmlns="" xmlns:a16="http://schemas.microsoft.com/office/drawing/2014/main" id="{AF1D65E8-027D-6F47-913F-2DDC0B156FAE}"/>
              </a:ext>
            </a:extLst>
          </p:cNvPr>
          <p:cNvSpPr/>
          <p:nvPr/>
        </p:nvSpPr>
        <p:spPr>
          <a:xfrm rot="20230453">
            <a:off x="8239729" y="5804805"/>
            <a:ext cx="327878" cy="326618"/>
          </a:xfrm>
          <a:prstGeom prst="chevron">
            <a:avLst/>
          </a:prstGeom>
          <a:solidFill>
            <a:schemeClr val="tx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>
              <a:solidFill>
                <a:schemeClr val="tx1"/>
              </a:solidFill>
              <a:highlight>
                <a:srgbClr val="000000"/>
              </a:highlight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="" xmlns:a16="http://schemas.microsoft.com/office/drawing/2014/main" id="{41D3EEE8-9687-2C4B-A40B-FCC21CA4B2BA}"/>
              </a:ext>
            </a:extLst>
          </p:cNvPr>
          <p:cNvCxnSpPr>
            <a:cxnSpLocks/>
          </p:cNvCxnSpPr>
          <p:nvPr/>
        </p:nvCxnSpPr>
        <p:spPr>
          <a:xfrm flipH="1" flipV="1">
            <a:off x="3951115" y="4023134"/>
            <a:ext cx="186073" cy="698279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="" xmlns:a16="http://schemas.microsoft.com/office/drawing/2014/main" id="{5301ACB9-5018-EA40-AD89-1549008ED6C6}"/>
              </a:ext>
            </a:extLst>
          </p:cNvPr>
          <p:cNvCxnSpPr>
            <a:cxnSpLocks/>
          </p:cNvCxnSpPr>
          <p:nvPr/>
        </p:nvCxnSpPr>
        <p:spPr>
          <a:xfrm>
            <a:off x="2812172" y="2893951"/>
            <a:ext cx="310574" cy="406947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="" xmlns:a16="http://schemas.microsoft.com/office/drawing/2014/main" id="{21CE2B82-F78C-FE42-A6DC-17CB0EE7E522}"/>
              </a:ext>
            </a:extLst>
          </p:cNvPr>
          <p:cNvCxnSpPr>
            <a:cxnSpLocks/>
          </p:cNvCxnSpPr>
          <p:nvPr/>
        </p:nvCxnSpPr>
        <p:spPr>
          <a:xfrm flipV="1">
            <a:off x="7361477" y="2346448"/>
            <a:ext cx="434409" cy="507964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Down Arrow 17">
            <a:extLst>
              <a:ext uri="{FF2B5EF4-FFF2-40B4-BE49-F238E27FC236}">
                <a16:creationId xmlns="" xmlns:a16="http://schemas.microsoft.com/office/drawing/2014/main" id="{C60A542F-E575-2942-BA92-D21AE93014E2}"/>
              </a:ext>
            </a:extLst>
          </p:cNvPr>
          <p:cNvSpPr/>
          <p:nvPr/>
        </p:nvSpPr>
        <p:spPr>
          <a:xfrm rot="2728415">
            <a:off x="4177689" y="1231294"/>
            <a:ext cx="357352" cy="404647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19" name="Down Arrow 18">
            <a:extLst>
              <a:ext uri="{FF2B5EF4-FFF2-40B4-BE49-F238E27FC236}">
                <a16:creationId xmlns="" xmlns:a16="http://schemas.microsoft.com/office/drawing/2014/main" id="{2706E7F2-29DF-0F41-81F7-966D59F079DB}"/>
              </a:ext>
            </a:extLst>
          </p:cNvPr>
          <p:cNvSpPr/>
          <p:nvPr/>
        </p:nvSpPr>
        <p:spPr>
          <a:xfrm rot="3610930">
            <a:off x="11743787" y="421043"/>
            <a:ext cx="357352" cy="404647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8159654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42A4FC2C-047E-45A5-965D-8E1E3BF09BC6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picture containing fabric&#10;&#10;Description automatically generated">
            <a:extLst>
              <a:ext uri="{FF2B5EF4-FFF2-40B4-BE49-F238E27FC236}">
                <a16:creationId xmlns="" xmlns:a16="http://schemas.microsoft.com/office/drawing/2014/main" id="{E281FF18-0CE0-E64F-8BA6-4DF88FDE1D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65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="" xmlns:a16="http://schemas.microsoft.com/office/drawing/2014/main" id="{FB9B926E-481B-0B44-A3FE-1FB3C6B6D71E}"/>
              </a:ext>
            </a:extLst>
          </p:cNvPr>
          <p:cNvCxnSpPr>
            <a:cxnSpLocks/>
          </p:cNvCxnSpPr>
          <p:nvPr/>
        </p:nvCxnSpPr>
        <p:spPr>
          <a:xfrm flipH="1">
            <a:off x="7393577" y="3334398"/>
            <a:ext cx="597860" cy="497481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="" xmlns:a16="http://schemas.microsoft.com/office/drawing/2014/main" id="{AA840BC4-0EEF-954A-90B7-593168B38B1E}"/>
              </a:ext>
            </a:extLst>
          </p:cNvPr>
          <p:cNvCxnSpPr>
            <a:cxnSpLocks/>
          </p:cNvCxnSpPr>
          <p:nvPr/>
        </p:nvCxnSpPr>
        <p:spPr>
          <a:xfrm flipH="1">
            <a:off x="9757954" y="1192089"/>
            <a:ext cx="597860" cy="497481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="" xmlns:a16="http://schemas.microsoft.com/office/drawing/2014/main" id="{F2DDB090-CC8C-2C42-B77C-D2D3442D0FE5}"/>
              </a:ext>
            </a:extLst>
          </p:cNvPr>
          <p:cNvCxnSpPr>
            <a:cxnSpLocks/>
          </p:cNvCxnSpPr>
          <p:nvPr/>
        </p:nvCxnSpPr>
        <p:spPr>
          <a:xfrm flipH="1">
            <a:off x="7485017" y="5244128"/>
            <a:ext cx="597860" cy="497481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="" xmlns:a16="http://schemas.microsoft.com/office/drawing/2014/main" id="{12060D6A-74CC-F749-8ED2-6F20A27166B9}"/>
              </a:ext>
            </a:extLst>
          </p:cNvPr>
          <p:cNvCxnSpPr>
            <a:cxnSpLocks/>
          </p:cNvCxnSpPr>
          <p:nvPr/>
        </p:nvCxnSpPr>
        <p:spPr>
          <a:xfrm flipV="1">
            <a:off x="4021845" y="1440829"/>
            <a:ext cx="968343" cy="321564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="" xmlns:a16="http://schemas.microsoft.com/office/drawing/2014/main" id="{5BC33603-0E20-2946-86F1-B0738C23E802}"/>
              </a:ext>
            </a:extLst>
          </p:cNvPr>
          <p:cNvCxnSpPr>
            <a:cxnSpLocks/>
          </p:cNvCxnSpPr>
          <p:nvPr/>
        </p:nvCxnSpPr>
        <p:spPr>
          <a:xfrm flipH="1" flipV="1">
            <a:off x="4622251" y="4588978"/>
            <a:ext cx="735873" cy="321564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="" xmlns:a16="http://schemas.microsoft.com/office/drawing/2014/main" id="{88AD734A-85C5-244D-AE7B-58E2C292D4EB}"/>
              </a:ext>
            </a:extLst>
          </p:cNvPr>
          <p:cNvCxnSpPr>
            <a:cxnSpLocks/>
          </p:cNvCxnSpPr>
          <p:nvPr/>
        </p:nvCxnSpPr>
        <p:spPr>
          <a:xfrm flipV="1">
            <a:off x="10703885" y="3334398"/>
            <a:ext cx="597860" cy="582467"/>
          </a:xfrm>
          <a:prstGeom prst="straightConnector1">
            <a:avLst/>
          </a:prstGeom>
          <a:ln w="3810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825883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cake, table, sitting, rug&#10;&#10;Description automatically generated">
            <a:extLst>
              <a:ext uri="{FF2B5EF4-FFF2-40B4-BE49-F238E27FC236}">
                <a16:creationId xmlns="" xmlns:a16="http://schemas.microsoft.com/office/drawing/2014/main" id="{B2DA1EA4-1AD2-0041-AEF2-F558ACE378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1754"/>
            <a:ext cx="12192000" cy="5954491"/>
          </a:xfrm>
          <a:prstGeom prst="rect">
            <a:avLst/>
          </a:prstGeom>
        </p:spPr>
      </p:pic>
      <p:sp>
        <p:nvSpPr>
          <p:cNvPr id="4" name="7-point Star 3">
            <a:extLst>
              <a:ext uri="{FF2B5EF4-FFF2-40B4-BE49-F238E27FC236}">
                <a16:creationId xmlns="" xmlns:a16="http://schemas.microsoft.com/office/drawing/2014/main" id="{DCCFDCD2-9DF6-4F4E-A2B7-DA475F0D17FE}"/>
              </a:ext>
            </a:extLst>
          </p:cNvPr>
          <p:cNvSpPr/>
          <p:nvPr/>
        </p:nvSpPr>
        <p:spPr>
          <a:xfrm>
            <a:off x="701040" y="1360715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  <p:sp>
        <p:nvSpPr>
          <p:cNvPr id="5" name="7-point Star 4">
            <a:extLst>
              <a:ext uri="{FF2B5EF4-FFF2-40B4-BE49-F238E27FC236}">
                <a16:creationId xmlns="" xmlns:a16="http://schemas.microsoft.com/office/drawing/2014/main" id="{38E5EBBD-4405-6241-AE5F-82DFCE0062E6}"/>
              </a:ext>
            </a:extLst>
          </p:cNvPr>
          <p:cNvSpPr/>
          <p:nvPr/>
        </p:nvSpPr>
        <p:spPr>
          <a:xfrm>
            <a:off x="9309463" y="1014549"/>
            <a:ext cx="391886" cy="346166"/>
          </a:xfrm>
          <a:prstGeom prst="star7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dirty="0"/>
          </a:p>
        </p:txBody>
      </p:sp>
    </p:spTree>
    <p:extLst>
      <p:ext uri="{BB962C8B-B14F-4D97-AF65-F5344CB8AC3E}">
        <p14:creationId xmlns:p14="http://schemas.microsoft.com/office/powerpoint/2010/main" val="3434643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32</Words>
  <Application>Microsoft Office PowerPoint</Application>
  <PresentationFormat>Custom</PresentationFormat>
  <Paragraphs>40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Supplementary Data </vt:lpstr>
      <vt:lpstr>INFORMATION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1: Comparison of scoring method used in this study with the one proposed by the International Society of Nephrology (ISN)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</dc:title>
  <dc:creator>Behnoush Abedi-Ardekani</dc:creator>
  <cp:lastModifiedBy>Alcarez, Janet</cp:lastModifiedBy>
  <cp:revision>10</cp:revision>
  <dcterms:created xsi:type="dcterms:W3CDTF">2020-08-06T13:38:28Z</dcterms:created>
  <dcterms:modified xsi:type="dcterms:W3CDTF">2020-12-12T18:54:33Z</dcterms:modified>
</cp:coreProperties>
</file>